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76"/>
  </p:normalViewPr>
  <p:slideViewPr>
    <p:cSldViewPr snapToGrid="0" snapToObjects="1">
      <p:cViewPr varScale="1">
        <p:scale>
          <a:sx n="52" d="100"/>
          <a:sy n="52" d="100"/>
        </p:scale>
        <p:origin x="229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436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2254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586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070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3337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30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704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633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179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672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0959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F0B6D-7322-6840-895E-D95DF85A671E}" type="datetimeFigureOut">
              <a:rPr lang="en-GB" smtClean="0"/>
              <a:t>1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E2F27-FF09-AD48-B775-DC7ADB5E83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41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xmlns="" id="{D4A0D898-0029-D440-9139-F3BAAD70FD95}"/>
              </a:ext>
            </a:extLst>
          </p:cNvPr>
          <p:cNvSpPr/>
          <p:nvPr/>
        </p:nvSpPr>
        <p:spPr>
          <a:xfrm>
            <a:off x="536169" y="5244222"/>
            <a:ext cx="578565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smtClean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dditional file </a:t>
            </a:r>
            <a:r>
              <a:rPr lang="en-US" sz="1200" b="1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1.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Zymogram gel showing aliquots (2µl) from 3-day old cultures of </a:t>
            </a:r>
            <a:r>
              <a:rPr lang="en-US" sz="1200" i="1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. </a:t>
            </a:r>
            <a:r>
              <a:rPr lang="en-US" sz="1200" i="1" dirty="0" err="1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gingivalis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strains [W50, 33F, SUB1 and 2 strains not otherwise mentioned in the paper (ATCC33277 and 16A) as well as commercial preparations of </a:t>
            </a:r>
            <a:r>
              <a:rPr lang="en-US" sz="1200" dirty="0" err="1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Kgp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RgpB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on a gelatin-containing gel stained with Coomassie brilliant blue. This image has not been subjected to digital enhancement.</a:t>
            </a:r>
            <a:endParaRPr lang="sv-S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5" name="Bild 1">
            <a:extLst>
              <a:ext uri="{FF2B5EF4-FFF2-40B4-BE49-F238E27FC236}">
                <a16:creationId xmlns:a16="http://schemas.microsoft.com/office/drawing/2014/main" xmlns="" id="{AF23618C-C2A2-9941-95EC-61045BC4257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7279" y="929005"/>
            <a:ext cx="4663440" cy="402399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28242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9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Julia Davies</dc:creator>
  <cp:lastModifiedBy>Abirami R.</cp:lastModifiedBy>
  <cp:revision>2</cp:revision>
  <dcterms:created xsi:type="dcterms:W3CDTF">2021-08-24T11:19:26Z</dcterms:created>
  <dcterms:modified xsi:type="dcterms:W3CDTF">2021-11-16T01:31:58Z</dcterms:modified>
</cp:coreProperties>
</file>